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37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D91D-37AF-4BA2-BA01-26C09240AFFD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F7198-C0E1-4EB7-8387-15E7F63A56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40671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D91D-37AF-4BA2-BA01-26C09240AFFD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F7198-C0E1-4EB7-8387-15E7F63A56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05408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D91D-37AF-4BA2-BA01-26C09240AFFD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F7198-C0E1-4EB7-8387-15E7F63A56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58332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D91D-37AF-4BA2-BA01-26C09240AFFD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F7198-C0E1-4EB7-8387-15E7F63A56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19728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D91D-37AF-4BA2-BA01-26C09240AFFD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F7198-C0E1-4EB7-8387-15E7F63A56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00731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D91D-37AF-4BA2-BA01-26C09240AFFD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F7198-C0E1-4EB7-8387-15E7F63A56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58135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D91D-37AF-4BA2-BA01-26C09240AFFD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F7198-C0E1-4EB7-8387-15E7F63A56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43246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D91D-37AF-4BA2-BA01-26C09240AFFD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F7198-C0E1-4EB7-8387-15E7F63A56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18810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D91D-37AF-4BA2-BA01-26C09240AFFD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F7198-C0E1-4EB7-8387-15E7F63A56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72929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D91D-37AF-4BA2-BA01-26C09240AFFD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F7198-C0E1-4EB7-8387-15E7F63A56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27911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9D91D-37AF-4BA2-BA01-26C09240AFFD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F7198-C0E1-4EB7-8387-15E7F63A56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42851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E9D91D-37AF-4BA2-BA01-26C09240AFFD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9F7198-C0E1-4EB7-8387-15E7F63A56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31777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33339" y="1191723"/>
            <a:ext cx="3312950" cy="2171921"/>
          </a:xfrm>
          <a:prstGeom prst="rect">
            <a:avLst/>
          </a:prstGeom>
        </p:spPr>
      </p:pic>
      <p:pic>
        <p:nvPicPr>
          <p:cNvPr id="36" name="Picture 3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33339" y="3369600"/>
            <a:ext cx="3390295" cy="2348655"/>
          </a:xfrm>
          <a:prstGeom prst="rect">
            <a:avLst/>
          </a:prstGeom>
        </p:spPr>
      </p:pic>
      <p:pic>
        <p:nvPicPr>
          <p:cNvPr id="35" name="Picture 34"/>
          <p:cNvPicPr>
            <a:picLocks noChangeAspect="1"/>
          </p:cNvPicPr>
          <p:nvPr/>
        </p:nvPicPr>
        <p:blipFill rotWithShape="1">
          <a:blip r:embed="rId4"/>
          <a:srcRect l="224" r="10976"/>
          <a:stretch/>
        </p:blipFill>
        <p:spPr>
          <a:xfrm>
            <a:off x="5867541" y="1181155"/>
            <a:ext cx="3293392" cy="2193058"/>
          </a:xfrm>
          <a:prstGeom prst="rect">
            <a:avLst/>
          </a:prstGeom>
        </p:spPr>
      </p:pic>
      <p:pic>
        <p:nvPicPr>
          <p:cNvPr id="34" name="Picture 3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962343" y="3576480"/>
            <a:ext cx="3584140" cy="2064315"/>
          </a:xfrm>
          <a:prstGeom prst="rect">
            <a:avLst/>
          </a:prstGeom>
        </p:spPr>
      </p:pic>
      <p:sp>
        <p:nvSpPr>
          <p:cNvPr id="4102" name="TextBox 9"/>
          <p:cNvSpPr txBox="1">
            <a:spLocks noChangeArrowheads="1"/>
          </p:cNvSpPr>
          <p:nvPr/>
        </p:nvSpPr>
        <p:spPr bwMode="auto">
          <a:xfrm>
            <a:off x="605977" y="5760824"/>
            <a:ext cx="570220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</a:t>
            </a:r>
            <a:r>
              <a:rPr lang="en-GB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ure </a:t>
            </a:r>
            <a:r>
              <a:rPr lang="en-GB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olated glomeruli restrict the passage of high molecular weight </a:t>
            </a:r>
            <a:r>
              <a:rPr lang="en-GB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lecules</a:t>
            </a:r>
            <a:endParaRPr lang="en-GB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107" name="Group 21"/>
          <p:cNvGrpSpPr>
            <a:grpSpLocks/>
          </p:cNvGrpSpPr>
          <p:nvPr/>
        </p:nvGrpSpPr>
        <p:grpSpPr bwMode="auto">
          <a:xfrm>
            <a:off x="7357294" y="1219016"/>
            <a:ext cx="1273371" cy="276998"/>
            <a:chOff x="1744570" y="4054103"/>
            <a:chExt cx="1694847" cy="262600"/>
          </a:xfrm>
        </p:grpSpPr>
        <p:cxnSp>
          <p:nvCxnSpPr>
            <p:cNvPr id="5" name="Straight Connector 4"/>
            <p:cNvCxnSpPr>
              <a:cxnSpLocks/>
            </p:cNvCxnSpPr>
            <p:nvPr/>
          </p:nvCxnSpPr>
          <p:spPr>
            <a:xfrm>
              <a:off x="1744570" y="4246248"/>
              <a:ext cx="169484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09" name="TextBox 16"/>
            <p:cNvSpPr txBox="1">
              <a:spLocks noChangeArrowheads="1"/>
            </p:cNvSpPr>
            <p:nvPr/>
          </p:nvSpPr>
          <p:spPr bwMode="auto">
            <a:xfrm>
              <a:off x="2499556" y="4054103"/>
              <a:ext cx="255619" cy="262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GB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sp>
        <p:nvSpPr>
          <p:cNvPr id="4105" name="TextBox 12"/>
          <p:cNvSpPr txBox="1">
            <a:spLocks noChangeArrowheads="1"/>
          </p:cNvSpPr>
          <p:nvPr/>
        </p:nvSpPr>
        <p:spPr bwMode="auto">
          <a:xfrm>
            <a:off x="6063947" y="3214577"/>
            <a:ext cx="3626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alt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i</a:t>
            </a:r>
            <a:endParaRPr lang="en-GB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10"/>
          <p:cNvSpPr txBox="1">
            <a:spLocks noChangeArrowheads="1"/>
          </p:cNvSpPr>
          <p:nvPr/>
        </p:nvSpPr>
        <p:spPr bwMode="auto">
          <a:xfrm>
            <a:off x="6096148" y="894106"/>
            <a:ext cx="28725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103" name="TextBox 10"/>
          <p:cNvSpPr txBox="1">
            <a:spLocks noChangeArrowheads="1"/>
          </p:cNvSpPr>
          <p:nvPr/>
        </p:nvSpPr>
        <p:spPr bwMode="auto">
          <a:xfrm>
            <a:off x="2396832" y="894106"/>
            <a:ext cx="287338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cxnSp>
        <p:nvCxnSpPr>
          <p:cNvPr id="31" name="Straight Connector 30"/>
          <p:cNvCxnSpPr>
            <a:cxnSpLocks/>
          </p:cNvCxnSpPr>
          <p:nvPr/>
        </p:nvCxnSpPr>
        <p:spPr bwMode="auto">
          <a:xfrm flipV="1">
            <a:off x="7407353" y="3656943"/>
            <a:ext cx="1313314" cy="762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16"/>
          <p:cNvSpPr txBox="1">
            <a:spLocks noChangeArrowheads="1"/>
          </p:cNvSpPr>
          <p:nvPr/>
        </p:nvSpPr>
        <p:spPr bwMode="auto">
          <a:xfrm>
            <a:off x="7985549" y="3470316"/>
            <a:ext cx="45571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GB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12"/>
          <p:cNvSpPr txBox="1">
            <a:spLocks noChangeArrowheads="1"/>
          </p:cNvSpPr>
          <p:nvPr/>
        </p:nvSpPr>
        <p:spPr bwMode="auto">
          <a:xfrm>
            <a:off x="2365185" y="3284936"/>
            <a:ext cx="32893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i</a:t>
            </a:r>
            <a:endParaRPr lang="en-GB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752992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71</TotalTime>
  <Words>20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MS PGothic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R Foster</dc:creator>
  <cp:lastModifiedBy>RR Foster</cp:lastModifiedBy>
  <cp:revision>32</cp:revision>
  <dcterms:created xsi:type="dcterms:W3CDTF">2017-07-28T14:07:01Z</dcterms:created>
  <dcterms:modified xsi:type="dcterms:W3CDTF">2017-11-17T15:44:09Z</dcterms:modified>
</cp:coreProperties>
</file>